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62" r:id="rId3"/>
    <p:sldId id="267" r:id="rId4"/>
    <p:sldId id="261" r:id="rId5"/>
    <p:sldId id="275" r:id="rId6"/>
    <p:sldId id="257" r:id="rId7"/>
    <p:sldId id="258" r:id="rId8"/>
    <p:sldId id="259" r:id="rId9"/>
    <p:sldId id="260" r:id="rId10"/>
    <p:sldId id="269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UBACH Florence" initials="TF" lastIdx="10" clrIdx="0">
    <p:extLst>
      <p:ext uri="{19B8F6BF-5375-455C-9EA6-DF929625EA0E}">
        <p15:presenceInfo xmlns:p15="http://schemas.microsoft.com/office/powerpoint/2012/main" userId="S-1-5-21-3834895988-1951830915-283893654-341496" providerId="AD"/>
      </p:ext>
    </p:extLst>
  </p:cmAuthor>
  <p:cmAuthor id="2" name="Cyrille Guillot-Tantay" initials="CG" lastIdx="8" clrIdx="1">
    <p:extLst>
      <p:ext uri="{19B8F6BF-5375-455C-9EA6-DF929625EA0E}">
        <p15:presenceInfo xmlns:p15="http://schemas.microsoft.com/office/powerpoint/2012/main" userId="1d1b252978a6a2a2" providerId="Windows Live"/>
      </p:ext>
    </p:extLst>
  </p:cmAuthor>
  <p:cmAuthor id="3" name="GUILLO Sylvie" initials="GS" lastIdx="7" clrIdx="2">
    <p:extLst>
      <p:ext uri="{19B8F6BF-5375-455C-9EA6-DF929625EA0E}">
        <p15:presenceInfo xmlns:p15="http://schemas.microsoft.com/office/powerpoint/2012/main" userId="S::sylvie.guillo@aphp.fr::16dd01ad-5ad8-4a4b-89d8-831b0765c41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Style léger 3 - Accentuation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376" autoAdjust="0"/>
    <p:restoredTop sz="95934"/>
  </p:normalViewPr>
  <p:slideViewPr>
    <p:cSldViewPr snapToGrid="0">
      <p:cViewPr>
        <p:scale>
          <a:sx n="140" d="100"/>
          <a:sy n="140" d="100"/>
        </p:scale>
        <p:origin x="1128" y="-18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7132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4158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1438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1896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673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1802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2323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5236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4605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2706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560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2F2A2-3C9C-1E42-B6EA-06A1DB1CB63A}" type="datetimeFigureOut">
              <a:rPr lang="fr-FR" smtClean="0"/>
              <a:t>18/06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ACE89F-2825-0F49-B408-6A6FB93FC96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345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D7CA903-5321-E450-0241-DE8000B370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159025"/>
            <a:ext cx="5829300" cy="500344"/>
          </a:xfrm>
        </p:spPr>
        <p:txBody>
          <a:bodyPr>
            <a:normAutofit/>
          </a:bodyPr>
          <a:lstStyle/>
          <a:p>
            <a:pPr algn="l"/>
            <a:r>
              <a:rPr lang="fr-FR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endParaRPr lang="fr-FR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AC318DE-EB2C-6A6B-9410-109A803B40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14350" y="818387"/>
            <a:ext cx="5143500" cy="6632279"/>
          </a:xfrm>
        </p:spPr>
        <p:txBody>
          <a:bodyPr>
            <a:normAutofit/>
          </a:bodyPr>
          <a:lstStyle/>
          <a:p>
            <a:pPr marL="342900" indent="-342900" algn="l">
              <a:buFont typeface="+mj-lt"/>
              <a:buAutoNum type="arabicPeriod"/>
            </a:pPr>
            <a:r>
              <a:rPr lang="en-GB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des </a:t>
            </a:r>
            <a:r>
              <a:rPr lang="en-GB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i</a:t>
            </a:r>
            <a:r>
              <a:rPr lang="en-GB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ntification of complications</a:t>
            </a:r>
          </a:p>
          <a:p>
            <a:pPr marL="342900" indent="-342900" algn="l">
              <a:buFont typeface="+mj-lt"/>
              <a:buAutoNum type="arabicPeriod"/>
            </a:pPr>
            <a:r>
              <a:rPr lang="en-GB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variate balance between the two groups before and after weighting (propensity score distributions and Love-plots) </a:t>
            </a:r>
          </a:p>
          <a:p>
            <a:pPr marL="342900" indent="-342900" algn="l">
              <a:buFont typeface="+mj-lt"/>
              <a:buAutoNum type="arabicPeriod"/>
            </a:pPr>
            <a:r>
              <a:rPr kumimoji="0" lang="en-US" altLang="fr-FR" sz="1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tribution of first </a:t>
            </a:r>
            <a:r>
              <a:rPr lang="en-US" altLang="fr-FR" sz="1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d-</a:t>
            </a:r>
            <a:r>
              <a:rPr kumimoji="0" lang="en-US" altLang="fr-FR" sz="18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rethral slings (MUS) implantation by year </a:t>
            </a:r>
          </a:p>
          <a:p>
            <a:pPr marL="342900" indent="-342900" algn="l">
              <a:buFont typeface="+mj-lt"/>
              <a:buAutoNum type="arabicPeriod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ude cumulative incidence of mid-urethral sling (MUS) section or removal</a:t>
            </a:r>
          </a:p>
          <a:p>
            <a:pPr marL="342900" indent="-342900" algn="l">
              <a:buFont typeface="+mj-lt"/>
              <a:buAutoNum type="arabicPeriod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ude cumulative incidence of  secondary outcomes</a:t>
            </a:r>
          </a:p>
          <a:p>
            <a:pPr marL="342900" indent="-342900" algn="l">
              <a:buFont typeface="+mj-lt"/>
              <a:buAutoNum type="arabicPeriod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ude cumulative incidence of at least one severe complication after mid-urethral sling (MUS) implantation</a:t>
            </a:r>
          </a:p>
          <a:p>
            <a:pPr marL="342900" indent="-342900" algn="l">
              <a:buFont typeface="+mj-lt"/>
              <a:buAutoNum type="arabicPeriod"/>
            </a:pP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ies (randomized controlled trial with more than 5 years of follow-up) comparing tension-free vaginal tapes (TVT) and trans-obturator tapes (TOT)</a:t>
            </a:r>
          </a:p>
          <a:p>
            <a:pPr marL="342900" indent="-342900" algn="l">
              <a:buFont typeface="+mj-lt"/>
              <a:buAutoNum type="arabicPeriod"/>
            </a:pP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indent="-342900" algn="l">
              <a:buFont typeface="+mj-lt"/>
              <a:buAutoNum type="arabicPeriod"/>
            </a:pP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88696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4F751D3F-D8D6-797A-9D8F-A8D42812029D}"/>
              </a:ext>
            </a:extLst>
          </p:cNvPr>
          <p:cNvSpPr txBox="1"/>
          <p:nvPr/>
        </p:nvSpPr>
        <p:spPr>
          <a:xfrm>
            <a:off x="298902" y="301758"/>
            <a:ext cx="62601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 7: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udies (randomized controlled trial with more than 5 years of follow-up) comparing </a:t>
            </a:r>
            <a:r>
              <a:rPr lang="en-US" sz="1000" b="1" dirty="0">
                <a:latin typeface="Times New Roman" panose="02020603050405020304" pitchFamily="18" charset="0"/>
                <a:ea typeface="Calibri" panose="020F0502020204030204" pitchFamily="34" charset="0"/>
              </a:rPr>
              <a:t>t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nsion-free vaginal tapes (TVT) and trans-obturator tapes (TOT)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id="{A9E18E5F-C555-7D29-3604-DAC005A161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7899231"/>
              </p:ext>
            </p:extLst>
          </p:nvPr>
        </p:nvGraphicFramePr>
        <p:xfrm>
          <a:off x="298902" y="1812005"/>
          <a:ext cx="6260196" cy="4044222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1009037">
                  <a:extLst>
                    <a:ext uri="{9D8B030D-6E8A-4147-A177-3AD203B41FA5}">
                      <a16:colId xmlns:a16="http://schemas.microsoft.com/office/drawing/2014/main" val="1359226726"/>
                    </a:ext>
                  </a:extLst>
                </a:gridCol>
                <a:gridCol w="428264">
                  <a:extLst>
                    <a:ext uri="{9D8B030D-6E8A-4147-A177-3AD203B41FA5}">
                      <a16:colId xmlns:a16="http://schemas.microsoft.com/office/drawing/2014/main" val="3276965582"/>
                    </a:ext>
                  </a:extLst>
                </a:gridCol>
                <a:gridCol w="567159">
                  <a:extLst>
                    <a:ext uri="{9D8B030D-6E8A-4147-A177-3AD203B41FA5}">
                      <a16:colId xmlns:a16="http://schemas.microsoft.com/office/drawing/2014/main" val="2439941983"/>
                    </a:ext>
                  </a:extLst>
                </a:gridCol>
                <a:gridCol w="613458">
                  <a:extLst>
                    <a:ext uri="{9D8B030D-6E8A-4147-A177-3AD203B41FA5}">
                      <a16:colId xmlns:a16="http://schemas.microsoft.com/office/drawing/2014/main" val="3250502954"/>
                    </a:ext>
                  </a:extLst>
                </a:gridCol>
                <a:gridCol w="439838">
                  <a:extLst>
                    <a:ext uri="{9D8B030D-6E8A-4147-A177-3AD203B41FA5}">
                      <a16:colId xmlns:a16="http://schemas.microsoft.com/office/drawing/2014/main" val="966733745"/>
                    </a:ext>
                  </a:extLst>
                </a:gridCol>
                <a:gridCol w="393539">
                  <a:extLst>
                    <a:ext uri="{9D8B030D-6E8A-4147-A177-3AD203B41FA5}">
                      <a16:colId xmlns:a16="http://schemas.microsoft.com/office/drawing/2014/main" val="708942927"/>
                    </a:ext>
                  </a:extLst>
                </a:gridCol>
                <a:gridCol w="626054">
                  <a:extLst>
                    <a:ext uri="{9D8B030D-6E8A-4147-A177-3AD203B41FA5}">
                      <a16:colId xmlns:a16="http://schemas.microsoft.com/office/drawing/2014/main" val="3503256207"/>
                    </a:ext>
                  </a:extLst>
                </a:gridCol>
                <a:gridCol w="612438">
                  <a:extLst>
                    <a:ext uri="{9D8B030D-6E8A-4147-A177-3AD203B41FA5}">
                      <a16:colId xmlns:a16="http://schemas.microsoft.com/office/drawing/2014/main" val="1705822977"/>
                    </a:ext>
                  </a:extLst>
                </a:gridCol>
                <a:gridCol w="821802">
                  <a:extLst>
                    <a:ext uri="{9D8B030D-6E8A-4147-A177-3AD203B41FA5}">
                      <a16:colId xmlns:a16="http://schemas.microsoft.com/office/drawing/2014/main" val="2760165155"/>
                    </a:ext>
                  </a:extLst>
                </a:gridCol>
                <a:gridCol w="748607">
                  <a:extLst>
                    <a:ext uri="{9D8B030D-6E8A-4147-A177-3AD203B41FA5}">
                      <a16:colId xmlns:a16="http://schemas.microsoft.com/office/drawing/2014/main" val="1995300228"/>
                    </a:ext>
                  </a:extLst>
                </a:gridCol>
              </a:tblGrid>
              <a:tr h="735682"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</a:t>
                      </a:r>
                      <a:endParaRPr lang="fr-FR" sz="11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endParaRPr lang="fr-FR" sz="11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of centers</a:t>
                      </a:r>
                      <a:endParaRPr lang="fr-FR" sz="11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low-up (months)</a:t>
                      </a:r>
                      <a:endParaRPr lang="fr-FR" sz="11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of patients included</a:t>
                      </a:r>
                      <a:endParaRPr lang="fr-FR" sz="1100" b="1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 (%) of patients loss of follow-up</a:t>
                      </a:r>
                      <a:endParaRPr lang="fr-FR" sz="11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alty</a:t>
                      </a:r>
                      <a:endParaRPr lang="fr-FR" sz="11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0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s</a:t>
                      </a:r>
                      <a:endParaRPr lang="fr-FR" sz="1100" b="1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extLst>
                  <a:ext uri="{0D108BD9-81ED-4DB2-BD59-A6C34878D82A}">
                    <a16:rowId xmlns:a16="http://schemas.microsoft.com/office/drawing/2014/main" val="1205404758"/>
                  </a:ext>
                </a:extLst>
              </a:tr>
              <a:tr h="2475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VT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VT</a:t>
                      </a:r>
                      <a:endParaRPr lang="fr-FR" sz="11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6823463"/>
                  </a:ext>
                </a:extLst>
              </a:tr>
              <a:tr h="459149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giol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17.1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 (16.2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necolog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fet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extLst>
                  <a:ext uri="{0D108BD9-81ED-4DB2-BD59-A6C34878D82A}">
                    <a16:rowId xmlns:a16="http://schemas.microsoft.com/office/drawing/2014/main" val="1340620687"/>
                  </a:ext>
                </a:extLst>
              </a:tr>
              <a:tr h="459149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o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fr-FR" sz="1100" kern="1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3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2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 (32.0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24.0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necolog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icac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extLst>
                  <a:ext uri="{0D108BD9-81ED-4DB2-BD59-A6C34878D82A}">
                    <a16:rowId xmlns:a16="http://schemas.microsoft.com/office/drawing/2014/main" val="303378241"/>
                  </a:ext>
                </a:extLst>
              </a:tr>
              <a:tr h="459149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hang </a:t>
                      </a: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fr-FR" sz="1100" kern="1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17.1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 (11.4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necolog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icac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extLst>
                  <a:ext uri="{0D108BD9-81ED-4DB2-BD59-A6C34878D82A}">
                    <a16:rowId xmlns:a16="http://schemas.microsoft.com/office/drawing/2014/main" val="2343860713"/>
                  </a:ext>
                </a:extLst>
              </a:tr>
              <a:tr h="459149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ss </a:t>
                      </a: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fr-FR" sz="1100" kern="1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11.4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 (11.7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necolog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fet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extLst>
                  <a:ext uri="{0D108BD9-81ED-4DB2-BD59-A6C34878D82A}">
                    <a16:rowId xmlns:a16="http://schemas.microsoft.com/office/drawing/2014/main" val="2494981911"/>
                  </a:ext>
                </a:extLst>
              </a:tr>
              <a:tr h="30610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urikainen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fr-FR" sz="1100" kern="1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(3.7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 (6.8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necolog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icac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extLst>
                  <a:ext uri="{0D108BD9-81ED-4DB2-BD59-A6C34878D82A}">
                    <a16:rowId xmlns:a16="http://schemas.microsoft.com/office/drawing/2014/main" val="652706924"/>
                  </a:ext>
                </a:extLst>
              </a:tr>
              <a:tr h="459149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mmaa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000" kern="1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fr-FR" sz="1100" kern="1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5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9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 (43.5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 (36.8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necolog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icac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extLst>
                  <a:ext uri="{0D108BD9-81ED-4DB2-BD59-A6C34878D82A}">
                    <a16:rowId xmlns:a16="http://schemas.microsoft.com/office/drawing/2014/main" val="3608705989"/>
                  </a:ext>
                </a:extLst>
              </a:tr>
              <a:tr h="459149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nton </a:t>
                      </a:r>
                      <a:r>
                        <a:rPr lang="en-US" sz="10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fr-FR" sz="1100" kern="100" baseline="30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8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9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 (34.2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 (25.1%)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ology and Gynecology</a:t>
                      </a:r>
                      <a:endParaRPr lang="fr-FR" sz="11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icacy</a:t>
                      </a:r>
                      <a:endParaRPr lang="fr-FR" sz="11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611" marR="62611" marT="0" marB="0" anchor="ctr"/>
                </a:tc>
                <a:extLst>
                  <a:ext uri="{0D108BD9-81ED-4DB2-BD59-A6C34878D82A}">
                    <a16:rowId xmlns:a16="http://schemas.microsoft.com/office/drawing/2014/main" val="7986619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891824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9360F26-B216-03D4-D139-6782041D0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767995"/>
          </a:xfrm>
        </p:spPr>
        <p:txBody>
          <a:bodyPr>
            <a:normAutofit/>
          </a:bodyPr>
          <a:lstStyle/>
          <a:p>
            <a:r>
              <a:rPr lang="en-US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1: Codes of identification of complication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2">
            <a:extLst>
              <a:ext uri="{FF2B5EF4-FFF2-40B4-BE49-F238E27FC236}">
                <a16:creationId xmlns:a16="http://schemas.microsoft.com/office/drawing/2014/main" id="{FA43EB14-5B3B-93EC-F2EE-70762793D5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93728" y="3011716"/>
            <a:ext cx="213520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 </a:t>
            </a:r>
            <a:endParaRPr kumimoji="0" lang="fr-FR" altLang="fr-FR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12" name="Tableau 11">
            <a:extLst>
              <a:ext uri="{FF2B5EF4-FFF2-40B4-BE49-F238E27FC236}">
                <a16:creationId xmlns:a16="http://schemas.microsoft.com/office/drawing/2014/main" id="{052A255F-3955-592C-5A62-184EF23631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866069"/>
              </p:ext>
            </p:extLst>
          </p:nvPr>
        </p:nvGraphicFramePr>
        <p:xfrm>
          <a:off x="471488" y="1430521"/>
          <a:ext cx="5915027" cy="8015105"/>
        </p:xfrm>
        <a:graphic>
          <a:graphicData uri="http://schemas.openxmlformats.org/drawingml/2006/table">
            <a:tbl>
              <a:tblPr firstRow="1" firstCol="1" bandRow="1">
                <a:tableStyleId>{8799B23B-EC83-4686-B30A-512413B5E67A}</a:tableStyleId>
              </a:tblPr>
              <a:tblGrid>
                <a:gridCol w="859098">
                  <a:extLst>
                    <a:ext uri="{9D8B030D-6E8A-4147-A177-3AD203B41FA5}">
                      <a16:colId xmlns:a16="http://schemas.microsoft.com/office/drawing/2014/main" val="2287926090"/>
                    </a:ext>
                  </a:extLst>
                </a:gridCol>
                <a:gridCol w="1684761">
                  <a:extLst>
                    <a:ext uri="{9D8B030D-6E8A-4147-A177-3AD203B41FA5}">
                      <a16:colId xmlns:a16="http://schemas.microsoft.com/office/drawing/2014/main" val="3573486775"/>
                    </a:ext>
                  </a:extLst>
                </a:gridCol>
                <a:gridCol w="1685584">
                  <a:extLst>
                    <a:ext uri="{9D8B030D-6E8A-4147-A177-3AD203B41FA5}">
                      <a16:colId xmlns:a16="http://schemas.microsoft.com/office/drawing/2014/main" val="534546295"/>
                    </a:ext>
                  </a:extLst>
                </a:gridCol>
                <a:gridCol w="1685584">
                  <a:extLst>
                    <a:ext uri="{9D8B030D-6E8A-4147-A177-3AD203B41FA5}">
                      <a16:colId xmlns:a16="http://schemas.microsoft.com/office/drawing/2014/main" val="753048996"/>
                    </a:ext>
                  </a:extLst>
                </a:gridCol>
              </a:tblGrid>
              <a:tr h="29667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u="non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lications</a:t>
                      </a:r>
                      <a:endParaRPr lang="fr-FR" sz="800" u="none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u="non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M / NABM codes</a:t>
                      </a:r>
                      <a:endParaRPr lang="fr-FR" sz="800" u="none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u="non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CD codes</a:t>
                      </a:r>
                      <a:endParaRPr lang="fr-FR" sz="800" u="none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fr-FR" sz="800" u="none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C Codes</a:t>
                      </a:r>
                    </a:p>
                  </a:txBody>
                  <a:tcPr marL="41671" marR="41671" marT="0" marB="0"/>
                </a:tc>
                <a:extLst>
                  <a:ext uri="{0D108BD9-81ED-4DB2-BD59-A6C34878D82A}">
                    <a16:rowId xmlns:a16="http://schemas.microsoft.com/office/drawing/2014/main" val="3475568669"/>
                  </a:ext>
                </a:extLst>
              </a:tr>
              <a:tr h="158776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 section</a:t>
                      </a:r>
                      <a:endParaRPr lang="fr-FR" sz="800" b="0" i="1" u="none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PA001:  sling section (vaginal approach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u="none" strike="noStrik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extLst>
                  <a:ext uri="{0D108BD9-81ED-4DB2-BD59-A6C34878D82A}">
                    <a16:rowId xmlns:a16="http://schemas.microsoft.com/office/drawing/2014/main" val="4124327123"/>
                  </a:ext>
                </a:extLst>
              </a:tr>
              <a:tr h="1270014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S removal </a:t>
                      </a:r>
                      <a:endParaRPr lang="fr-FR" sz="800" b="0" i="1" u="none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A001: total sling removal (vaginal approach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A002: partial sling removal (laparotomy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A003: total sling removal (vaginal and laparotomy approach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A004: partial sling removal (laparoscopy and vaginal approach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C001: partial sling removal (laparoscopy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u="none" strike="noStrik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extLst>
                  <a:ext uri="{0D108BD9-81ED-4DB2-BD59-A6C34878D82A}">
                    <a16:rowId xmlns:a16="http://schemas.microsoft.com/office/drawing/2014/main" val="2622323449"/>
                  </a:ext>
                </a:extLst>
              </a:tr>
              <a:tr h="3439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cond MUS implantation</a:t>
                      </a:r>
                      <a:endParaRPr lang="fr-FR" sz="800" b="0" i="1" u="none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DDB005: TOT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DDB007: TVT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u="none" strike="noStrik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extLst>
                  <a:ext uri="{0D108BD9-81ED-4DB2-BD59-A6C34878D82A}">
                    <a16:rowId xmlns:a16="http://schemas.microsoft.com/office/drawing/2014/main" val="3973282621"/>
                  </a:ext>
                </a:extLst>
              </a:tr>
              <a:tr h="694436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spitalizations for MUS</a:t>
                      </a:r>
                      <a:endParaRPr lang="fr-FR" sz="800" b="0" i="1" u="none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osion</a:t>
                      </a:r>
                      <a:endParaRPr lang="fr-FR" sz="800" b="0" i="1" u="none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83.1: Mechanical complication of prosthesis and urinary implants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83.5: Infection and inflammatory reaction due to a prosthesis, an implant and a graft of the urinary tract</a:t>
                      </a:r>
                      <a:endParaRPr lang="fr-FR" sz="7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extLst>
                  <a:ext uri="{0D108BD9-81ED-4DB2-BD59-A6C34878D82A}">
                    <a16:rowId xmlns:a16="http://schemas.microsoft.com/office/drawing/2014/main" val="16891414"/>
                  </a:ext>
                </a:extLst>
              </a:tr>
              <a:tr h="71439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spitalizations for MUS</a:t>
                      </a:r>
                      <a:endParaRPr lang="fr-FR" sz="800" b="0" i="1" u="none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fections</a:t>
                      </a:r>
                      <a:endParaRPr lang="fr-FR" sz="800" b="0" i="1" u="none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83.5: Infection and inflammatory reaction due to a prosthesis, an implant and a graft of the urinary tract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83.6: Infection and inflammatory reaction due to a prosthesis, an implant and a graft of the genital tract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endParaRPr lang="fr-FR" sz="1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4450" marR="44450" marT="0" marB="0"/>
                </a:tc>
                <a:extLst>
                  <a:ext uri="{0D108BD9-81ED-4DB2-BD59-A6C34878D82A}">
                    <a16:rowId xmlns:a16="http://schemas.microsoft.com/office/drawing/2014/main" val="1778831216"/>
                  </a:ext>
                </a:extLst>
              </a:tr>
              <a:tr h="3439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spitalizations for urinary retention</a:t>
                      </a:r>
                      <a:endParaRPr lang="fr-FR" sz="800" b="0" i="1" u="none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JRPA001:  sling section (vaginal approach)</a:t>
                      </a:r>
                      <a:endParaRPr lang="fr-FR" sz="7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30: Dysuria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33: Urinary retention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extLst>
                  <a:ext uri="{0D108BD9-81ED-4DB2-BD59-A6C34878D82A}">
                    <a16:rowId xmlns:a16="http://schemas.microsoft.com/office/drawing/2014/main" val="3586083815"/>
                  </a:ext>
                </a:extLst>
              </a:tr>
              <a:tr h="182563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spitalizations for at least one complication </a:t>
                      </a:r>
                      <a:endParaRPr lang="fr-FR" sz="800" b="0" i="1" u="none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A001: total sling removal (vaginal approach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A002: partial sling removal (laparotomy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A003: total sling removal (vaginal and laparotomy approach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A004: partial sling removal (laparoscopy and vaginal approach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GC001: partial sling removal (laparoscopy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RPA001:  sling section (vaginal approach)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83.1: Mechanical complication of prosthesis and urinary implants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83.4: Mechanical complication of prosthesis, implants and grafts of the genital tract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83.5: Infection and inflammatory reaction due to a prosthesis, an implant and a graft of the urinary tract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83.6: Infection and inflammatory reaction due to a prosthesis, an implant and a graft of the genital tract</a:t>
                      </a: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extLst>
                  <a:ext uri="{0D108BD9-81ED-4DB2-BD59-A6C34878D82A}">
                    <a16:rowId xmlns:a16="http://schemas.microsoft.com/office/drawing/2014/main" val="24573096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221395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5E5A53BA-A509-5E60-3266-6B9E36E10300}"/>
              </a:ext>
            </a:extLst>
          </p:cNvPr>
          <p:cNvSpPr txBox="1"/>
          <p:nvPr/>
        </p:nvSpPr>
        <p:spPr>
          <a:xfrm>
            <a:off x="352954" y="6374352"/>
            <a:ext cx="14750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: Mid-urethral sling</a:t>
            </a:r>
          </a:p>
        </p:txBody>
      </p:sp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id="{39254165-6347-E3D9-95B7-1D9800E88A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7668262"/>
              </p:ext>
            </p:extLst>
          </p:nvPr>
        </p:nvGraphicFramePr>
        <p:xfrm>
          <a:off x="352954" y="706304"/>
          <a:ext cx="5861578" cy="5032161"/>
        </p:xfrm>
        <a:graphic>
          <a:graphicData uri="http://schemas.openxmlformats.org/drawingml/2006/table">
            <a:tbl>
              <a:tblPr firstRow="1" firstCol="1" bandRow="1">
                <a:tableStyleId>{8799B23B-EC83-4686-B30A-512413B5E67A}</a:tableStyleId>
              </a:tblPr>
              <a:tblGrid>
                <a:gridCol w="851335">
                  <a:extLst>
                    <a:ext uri="{9D8B030D-6E8A-4147-A177-3AD203B41FA5}">
                      <a16:colId xmlns:a16="http://schemas.microsoft.com/office/drawing/2014/main" val="2287926090"/>
                    </a:ext>
                  </a:extLst>
                </a:gridCol>
                <a:gridCol w="1669537">
                  <a:extLst>
                    <a:ext uri="{9D8B030D-6E8A-4147-A177-3AD203B41FA5}">
                      <a16:colId xmlns:a16="http://schemas.microsoft.com/office/drawing/2014/main" val="3573486775"/>
                    </a:ext>
                  </a:extLst>
                </a:gridCol>
                <a:gridCol w="1670353">
                  <a:extLst>
                    <a:ext uri="{9D8B030D-6E8A-4147-A177-3AD203B41FA5}">
                      <a16:colId xmlns:a16="http://schemas.microsoft.com/office/drawing/2014/main" val="534546295"/>
                    </a:ext>
                  </a:extLst>
                </a:gridCol>
                <a:gridCol w="1670353">
                  <a:extLst>
                    <a:ext uri="{9D8B030D-6E8A-4147-A177-3AD203B41FA5}">
                      <a16:colId xmlns:a16="http://schemas.microsoft.com/office/drawing/2014/main" val="75304899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onic pain</a:t>
                      </a:r>
                      <a:endParaRPr lang="fr-FR" sz="800" b="0" i="1" u="none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endParaRPr lang="fr-FR" sz="8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u="none" strike="noStrik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fr-FR" sz="7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02A: </a:t>
                      </a:r>
                      <a:r>
                        <a:rPr lang="en-US" sz="700" b="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pioid analgesics </a:t>
                      </a:r>
                      <a:endParaRPr lang="fr-FR" sz="700" b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02B: </a:t>
                      </a:r>
                      <a:r>
                        <a:rPr lang="en-US" sz="700" b="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analgesics and antipyretics  </a:t>
                      </a:r>
                    </a:p>
                  </a:txBody>
                  <a:tcPr marL="44450" marR="44450" marT="0" marB="0"/>
                </a:tc>
                <a:extLst>
                  <a:ext uri="{0D108BD9-81ED-4DB2-BD59-A6C34878D82A}">
                    <a16:rowId xmlns:a16="http://schemas.microsoft.com/office/drawing/2014/main" val="4124327123"/>
                  </a:ext>
                </a:extLst>
              </a:tr>
              <a:tr h="228985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fr-FR" sz="800" b="0" i="1" u="none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veractive</a:t>
                      </a:r>
                      <a:r>
                        <a:rPr lang="fr-FR" sz="800" b="0" i="1" u="none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800" b="0" i="1" u="none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ladder</a:t>
                      </a:r>
                      <a:endParaRPr lang="fr-FR" sz="800" b="0" i="1" u="none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endParaRPr lang="fr-FR" sz="8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US" sz="700" u="none" strike="noStrike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800" kern="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04BD: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ological antispasmodics and drugs used for bladder function disorders  </a:t>
                      </a:r>
                    </a:p>
                  </a:txBody>
                  <a:tcPr marL="44450" marR="44450" marT="0" marB="0"/>
                </a:tc>
                <a:extLst>
                  <a:ext uri="{0D108BD9-81ED-4DB2-BD59-A6C34878D82A}">
                    <a16:rowId xmlns:a16="http://schemas.microsoft.com/office/drawing/2014/main" val="2622323449"/>
                  </a:ext>
                </a:extLst>
              </a:tr>
              <a:tr h="49100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US" sz="700" b="0" i="1" u="non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rinary infection</a:t>
                      </a:r>
                      <a:endParaRPr lang="fr-FR" sz="800" b="0" i="1" u="none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fr-FR" sz="8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01: urine culture</a:t>
                      </a: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endParaRPr lang="en-US" sz="700" u="none" strike="noStrike" kern="1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01C:  </a:t>
                      </a:r>
                      <a:r>
                        <a:rPr lang="en-US" sz="700" b="0" u="none" strike="noStrike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arge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trum </a:t>
                      </a:r>
                      <a:r>
                        <a:rPr lang="en-US" sz="700" u="none" strike="noStrike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nicillins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fr-FR" sz="7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01D: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</a:t>
                      </a:r>
                      <a:r>
                        <a:rPr lang="en-US" sz="700" u="none" strike="noStrike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nicillins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fr-FR" sz="7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01E: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lfonamides</a:t>
                      </a:r>
                      <a:endParaRPr lang="fr-FR" sz="7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01G: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iotics based on cephalosporins </a:t>
                      </a:r>
                      <a:endParaRPr lang="fr-FR" sz="7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01M: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rolides, </a:t>
                      </a:r>
                      <a:r>
                        <a:rPr lang="en-US" sz="700" u="none" strike="noStrike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cosamides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and streptogramins</a:t>
                      </a:r>
                      <a:endParaRPr lang="fr-FR" sz="7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01XA: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nicillin-based antibiotics</a:t>
                      </a:r>
                      <a:endParaRPr lang="fr-FR" sz="7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01XE: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antibiotics</a:t>
                      </a:r>
                      <a:endParaRPr lang="fr-FR" sz="7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01XXA: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systemic antibiotics  </a:t>
                      </a:r>
                      <a:endParaRPr lang="fr-FR" sz="7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l" defTabSz="6858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700" b="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01XX01: </a:t>
                      </a:r>
                      <a:r>
                        <a:rPr lang="en-US" sz="700" u="none" strike="noStrike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fic other systemic antibiotics</a:t>
                      </a:r>
                      <a:endParaRPr lang="fr-FR" sz="700" b="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1671" marR="41671" marT="0" marB="0"/>
                </a:tc>
                <a:extLst>
                  <a:ext uri="{0D108BD9-81ED-4DB2-BD59-A6C34878D82A}">
                    <a16:rowId xmlns:a16="http://schemas.microsoft.com/office/drawing/2014/main" val="39732826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673846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Image 1">
            <a:extLst>
              <a:ext uri="{FF2B5EF4-FFF2-40B4-BE49-F238E27FC236}">
                <a16:creationId xmlns:a16="http://schemas.microsoft.com/office/drawing/2014/main" id="{967C469D-41F5-83A2-52C9-76E8D3D31C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545" y="1806831"/>
            <a:ext cx="5765800" cy="3898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Image 1334291628">
            <a:extLst>
              <a:ext uri="{FF2B5EF4-FFF2-40B4-BE49-F238E27FC236}">
                <a16:creationId xmlns:a16="http://schemas.microsoft.com/office/drawing/2014/main" id="{B031F39A-DBC1-1996-44A3-0B48BC3E13A5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067" y="5869631"/>
            <a:ext cx="5943600" cy="381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E17122B-3F50-D323-34DE-0B745DB9E4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816610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BBF9848-5C51-CDFE-293F-0CBBAA37EDC1}"/>
              </a:ext>
            </a:extLst>
          </p:cNvPr>
          <p:cNvSpPr txBox="1"/>
          <p:nvPr/>
        </p:nvSpPr>
        <p:spPr>
          <a:xfrm>
            <a:off x="174725" y="5567231"/>
            <a:ext cx="90170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r>
              <a:rPr kumimoji="0" lang="fr-FR" altLang="fr-FR" sz="10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ve plots</a:t>
            </a:r>
            <a:endParaRPr kumimoji="0" lang="fr-FR" altLang="fr-FR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9C545687-2772-1353-D808-03D9F9CD8B2F}"/>
              </a:ext>
            </a:extLst>
          </p:cNvPr>
          <p:cNvSpPr txBox="1"/>
          <p:nvPr/>
        </p:nvSpPr>
        <p:spPr>
          <a:xfrm>
            <a:off x="92365" y="1587943"/>
            <a:ext cx="2098965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fr-FR" sz="1000" i="0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pensity score distribution</a:t>
            </a:r>
            <a:endParaRPr kumimoji="0" lang="en-US" altLang="fr-FR" sz="1000" i="0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endParaRPr kumimoji="0" lang="fr-FR" altLang="fr-FR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486584C4-819E-8501-51A2-5D6E7185C5E7}"/>
              </a:ext>
            </a:extLst>
          </p:cNvPr>
          <p:cNvSpPr txBox="1"/>
          <p:nvPr/>
        </p:nvSpPr>
        <p:spPr>
          <a:xfrm>
            <a:off x="211666" y="339886"/>
            <a:ext cx="6434667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fr-FR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2: Covariate balance between the two groups before and after weighting (propensity score distributions and Love-plots)</a:t>
            </a:r>
            <a:endParaRPr kumimoji="0" lang="en-US" altLang="fr-FR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52EAB188-84D4-77F3-6A1E-F3893D182CCA}"/>
              </a:ext>
            </a:extLst>
          </p:cNvPr>
          <p:cNvSpPr txBox="1"/>
          <p:nvPr/>
        </p:nvSpPr>
        <p:spPr>
          <a:xfrm>
            <a:off x="4613180" y="5392277"/>
            <a:ext cx="21112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: Trans-obturator tape</a:t>
            </a:r>
          </a:p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VT: Tension-free vaginal tape</a:t>
            </a:r>
          </a:p>
        </p:txBody>
      </p:sp>
    </p:spTree>
    <p:extLst>
      <p:ext uri="{BB962C8B-B14F-4D97-AF65-F5344CB8AC3E}">
        <p14:creationId xmlns:p14="http://schemas.microsoft.com/office/powerpoint/2010/main" val="10402010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ED3F2B9-A5E1-2C28-FEA5-034F0BB7C9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653695"/>
          </a:xfrm>
        </p:spPr>
        <p:txBody>
          <a:bodyPr>
            <a:normAutofit/>
          </a:bodyPr>
          <a:lstStyle/>
          <a:p>
            <a:r>
              <a:rPr kumimoji="0" lang="en-US" altLang="fr-FR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3: Distribution of first </a:t>
            </a:r>
            <a:r>
              <a:rPr lang="en-US" altLang="fr-FR" sz="10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d-</a:t>
            </a:r>
            <a:r>
              <a:rPr kumimoji="0" lang="en-US" altLang="fr-FR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rethral slings (MUS) implantation by year</a:t>
            </a:r>
            <a:endParaRPr lang="en-US" sz="1000" dirty="0"/>
          </a:p>
        </p:txBody>
      </p:sp>
      <p:graphicFrame>
        <p:nvGraphicFramePr>
          <p:cNvPr id="9" name="Espace réservé du contenu 8">
            <a:extLst>
              <a:ext uri="{FF2B5EF4-FFF2-40B4-BE49-F238E27FC236}">
                <a16:creationId xmlns:a16="http://schemas.microsoft.com/office/drawing/2014/main" id="{AD971D75-8232-8164-67A7-89245AE355D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940051899"/>
              </p:ext>
            </p:extLst>
          </p:nvPr>
        </p:nvGraphicFramePr>
        <p:xfrm>
          <a:off x="484188" y="1385094"/>
          <a:ext cx="5079998" cy="2235200"/>
        </p:xfrm>
        <a:graphic>
          <a:graphicData uri="http://schemas.openxmlformats.org/drawingml/2006/table">
            <a:tbl>
              <a:tblPr firstRow="1" firstCol="1" lastRow="1">
                <a:tableStyleId>{F5AB1C69-6EDB-4FF4-983F-18BD219EF322}</a:tableStyleId>
              </a:tblPr>
              <a:tblGrid>
                <a:gridCol w="826608">
                  <a:extLst>
                    <a:ext uri="{9D8B030D-6E8A-4147-A177-3AD203B41FA5}">
                      <a16:colId xmlns:a16="http://schemas.microsoft.com/office/drawing/2014/main" val="2804418860"/>
                    </a:ext>
                  </a:extLst>
                </a:gridCol>
                <a:gridCol w="826608">
                  <a:extLst>
                    <a:ext uri="{9D8B030D-6E8A-4147-A177-3AD203B41FA5}">
                      <a16:colId xmlns:a16="http://schemas.microsoft.com/office/drawing/2014/main" val="1248534086"/>
                    </a:ext>
                  </a:extLst>
                </a:gridCol>
                <a:gridCol w="886783">
                  <a:extLst>
                    <a:ext uri="{9D8B030D-6E8A-4147-A177-3AD203B41FA5}">
                      <a16:colId xmlns:a16="http://schemas.microsoft.com/office/drawing/2014/main" val="879506464"/>
                    </a:ext>
                  </a:extLst>
                </a:gridCol>
                <a:gridCol w="826608">
                  <a:extLst>
                    <a:ext uri="{9D8B030D-6E8A-4147-A177-3AD203B41FA5}">
                      <a16:colId xmlns:a16="http://schemas.microsoft.com/office/drawing/2014/main" val="2258898640"/>
                    </a:ext>
                  </a:extLst>
                </a:gridCol>
                <a:gridCol w="826608">
                  <a:extLst>
                    <a:ext uri="{9D8B030D-6E8A-4147-A177-3AD203B41FA5}">
                      <a16:colId xmlns:a16="http://schemas.microsoft.com/office/drawing/2014/main" val="1498990528"/>
                    </a:ext>
                  </a:extLst>
                </a:gridCol>
                <a:gridCol w="886783">
                  <a:extLst>
                    <a:ext uri="{9D8B030D-6E8A-4147-A177-3AD203B41FA5}">
                      <a16:colId xmlns:a16="http://schemas.microsoft.com/office/drawing/2014/main" val="287799758"/>
                    </a:ext>
                  </a:extLst>
                </a:gridCol>
              </a:tblGrid>
              <a:tr h="20320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VT</a:t>
                      </a:r>
                      <a:endParaRPr lang="fr-FR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31465888"/>
                  </a:ext>
                </a:extLst>
              </a:tr>
              <a:tr h="2032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fr-FR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fr-FR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228362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,36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.7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6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3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,997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352499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,28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.3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53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,82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5318070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,8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.9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3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1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,184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743134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,14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.8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10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2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,246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1484602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,10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8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7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2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,837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6046906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6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,77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.5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4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5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,184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6364754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,9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.4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25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6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,183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3381529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8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,38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.1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30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9%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,69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7179626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0,781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.4%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,360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6%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5,141</a:t>
                      </a:r>
                      <a:endParaRPr lang="fr-FR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92209716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BBC4BA88-D607-8882-BF72-913A46137EBE}"/>
              </a:ext>
            </a:extLst>
          </p:cNvPr>
          <p:cNvSpPr txBox="1"/>
          <p:nvPr/>
        </p:nvSpPr>
        <p:spPr>
          <a:xfrm>
            <a:off x="770575" y="4234191"/>
            <a:ext cx="2024913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CA" sz="1100" kern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T: Trans-Obturator Tape</a:t>
            </a:r>
          </a:p>
          <a:p>
            <a:r>
              <a:rPr lang="en-CA" sz="1100" kern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VT: Tension-free Vaginal Tape 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9860381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E0457D20-2F44-1473-ED27-8DF9214195A1}"/>
              </a:ext>
            </a:extLst>
          </p:cNvPr>
          <p:cNvSpPr txBox="1"/>
          <p:nvPr/>
        </p:nvSpPr>
        <p:spPr>
          <a:xfrm>
            <a:off x="530070" y="286969"/>
            <a:ext cx="486559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: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de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mulative incidence of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d-urethral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ling (MUS) section or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moval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k</a:t>
            </a:r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s</a:t>
            </a:r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cumulative incidence, and th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ghter</a:t>
            </a:r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a the 95% confidenc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val</a:t>
            </a:r>
            <a:endParaRPr lang="fr-FR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leau 7">
            <a:extLst>
              <a:ext uri="{FF2B5EF4-FFF2-40B4-BE49-F238E27FC236}">
                <a16:creationId xmlns:a16="http://schemas.microsoft.com/office/drawing/2014/main" id="{37D5AEFE-94E8-7B68-778B-1935CFE37F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2029578"/>
              </p:ext>
            </p:extLst>
          </p:nvPr>
        </p:nvGraphicFramePr>
        <p:xfrm>
          <a:off x="530070" y="4124453"/>
          <a:ext cx="4643436" cy="762000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928440">
                  <a:extLst>
                    <a:ext uri="{9D8B030D-6E8A-4147-A177-3AD203B41FA5}">
                      <a16:colId xmlns:a16="http://schemas.microsoft.com/office/drawing/2014/main" val="1277197416"/>
                    </a:ext>
                  </a:extLst>
                </a:gridCol>
                <a:gridCol w="1857498">
                  <a:extLst>
                    <a:ext uri="{9D8B030D-6E8A-4147-A177-3AD203B41FA5}">
                      <a16:colId xmlns:a16="http://schemas.microsoft.com/office/drawing/2014/main" val="3382227845"/>
                    </a:ext>
                  </a:extLst>
                </a:gridCol>
                <a:gridCol w="1857498">
                  <a:extLst>
                    <a:ext uri="{9D8B030D-6E8A-4147-A177-3AD203B41FA5}">
                      <a16:colId xmlns:a16="http://schemas.microsoft.com/office/drawing/2014/main" val="363667501"/>
                    </a:ext>
                  </a:extLst>
                </a:gridCol>
              </a:tblGrid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(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V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 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extLst>
                  <a:ext uri="{0D108BD9-81ED-4DB2-BD59-A6C34878D82A}">
                    <a16:rowId xmlns:a16="http://schemas.microsoft.com/office/drawing/2014/main" val="1677665871"/>
                  </a:ext>
                </a:extLst>
              </a:tr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 (1.55 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7)</a:t>
                      </a: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7 (2.33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2)</a:t>
                      </a:r>
                    </a:p>
                  </a:txBody>
                  <a:tcPr marL="55721" marR="55721" marT="0" marB="0"/>
                </a:tc>
                <a:extLst>
                  <a:ext uri="{0D108BD9-81ED-4DB2-BD59-A6C34878D82A}">
                    <a16:rowId xmlns:a16="http://schemas.microsoft.com/office/drawing/2014/main" val="1978678880"/>
                  </a:ext>
                </a:extLst>
              </a:tr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2 (2.45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1)</a:t>
                      </a: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4 (3.27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1)</a:t>
                      </a:r>
                    </a:p>
                  </a:txBody>
                  <a:tcPr marL="55721" marR="55721" marT="0" marB="0"/>
                </a:tc>
                <a:extLst>
                  <a:ext uri="{0D108BD9-81ED-4DB2-BD59-A6C34878D82A}">
                    <a16:rowId xmlns:a16="http://schemas.microsoft.com/office/drawing/2014/main" val="1415413905"/>
                  </a:ext>
                </a:extLst>
              </a:tr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4 (3.15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3)</a:t>
                      </a: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3 (3.94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2)</a:t>
                      </a:r>
                    </a:p>
                  </a:txBody>
                  <a:tcPr marL="55721" marR="55721" marT="0" marB="0"/>
                </a:tc>
                <a:extLst>
                  <a:ext uri="{0D108BD9-81ED-4DB2-BD59-A6C34878D82A}">
                    <a16:rowId xmlns:a16="http://schemas.microsoft.com/office/drawing/2014/main" val="4068265657"/>
                  </a:ext>
                </a:extLst>
              </a:tr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8 (3.48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8)</a:t>
                      </a: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2 (4.4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4)</a:t>
                      </a:r>
                    </a:p>
                  </a:txBody>
                  <a:tcPr marL="55721" marR="55721" marT="0" marB="0"/>
                </a:tc>
                <a:extLst>
                  <a:ext uri="{0D108BD9-81ED-4DB2-BD59-A6C34878D82A}">
                    <a16:rowId xmlns:a16="http://schemas.microsoft.com/office/drawing/2014/main" val="1378539236"/>
                  </a:ext>
                </a:extLst>
              </a:tr>
            </a:tbl>
          </a:graphicData>
        </a:graphic>
      </p:graphicFrame>
      <p:pic>
        <p:nvPicPr>
          <p:cNvPr id="2" name="Image 1">
            <a:extLst>
              <a:ext uri="{FF2B5EF4-FFF2-40B4-BE49-F238E27FC236}">
                <a16:creationId xmlns:a16="http://schemas.microsoft.com/office/drawing/2014/main" id="{BA0DE1AF-7010-9752-1E8A-F81EE7249EF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20" r="49107"/>
          <a:stretch/>
        </p:blipFill>
        <p:spPr>
          <a:xfrm>
            <a:off x="736290" y="1186078"/>
            <a:ext cx="3666377" cy="2785246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5088E9FD-5328-6C47-FC72-A5B3A74E8D6C}"/>
              </a:ext>
            </a:extLst>
          </p:cNvPr>
          <p:cNvSpPr txBox="1"/>
          <p:nvPr/>
        </p:nvSpPr>
        <p:spPr>
          <a:xfrm>
            <a:off x="530070" y="5233258"/>
            <a:ext cx="1960793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CA" sz="1100" kern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T: Trans-Obturator Tape</a:t>
            </a:r>
          </a:p>
          <a:p>
            <a:r>
              <a:rPr lang="en-CA" sz="1100" kern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VT: </a:t>
            </a:r>
            <a:r>
              <a:rPr lang="en-CA" sz="1100" kern="14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ension-free Vaginal Tape</a:t>
            </a:r>
          </a:p>
          <a:p>
            <a:r>
              <a:rPr lang="fr-FR" sz="1100" dirty="0">
                <a:cs typeface="Times New Roman" panose="02020603050405020304" pitchFamily="18" charset="0"/>
              </a:rPr>
              <a:t>CI: Confidence </a:t>
            </a:r>
            <a:r>
              <a:rPr lang="fr-FR" sz="1100" dirty="0" err="1">
                <a:cs typeface="Times New Roman" panose="02020603050405020304" pitchFamily="18" charset="0"/>
              </a:rPr>
              <a:t>Interval</a:t>
            </a:r>
            <a:r>
              <a:rPr lang="en-CA" sz="1100" kern="14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88641021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E0457D20-2F44-1473-ED27-8DF9214195A1}"/>
              </a:ext>
            </a:extLst>
          </p:cNvPr>
          <p:cNvSpPr txBox="1"/>
          <p:nvPr/>
        </p:nvSpPr>
        <p:spPr>
          <a:xfrm>
            <a:off x="298935" y="201720"/>
            <a:ext cx="598842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: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de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mulative incidence of 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condary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comes</a:t>
            </a:r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k</a:t>
            </a:r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s</a:t>
            </a:r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cumulative incidence, and th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ghter</a:t>
            </a:r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a the 95% confidenc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val</a:t>
            </a:r>
            <a:endParaRPr lang="fr-FR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E48AD370-2469-040F-3203-C0CCAE501B71}"/>
              </a:ext>
            </a:extLst>
          </p:cNvPr>
          <p:cNvSpPr txBox="1"/>
          <p:nvPr/>
        </p:nvSpPr>
        <p:spPr>
          <a:xfrm>
            <a:off x="3625128" y="5308317"/>
            <a:ext cx="20938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spitalizations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inary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tention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FA6C6591-12B7-985E-A0F8-2284CA7F10C5}"/>
              </a:ext>
            </a:extLst>
          </p:cNvPr>
          <p:cNvSpPr txBox="1"/>
          <p:nvPr/>
        </p:nvSpPr>
        <p:spPr>
          <a:xfrm>
            <a:off x="298935" y="1068790"/>
            <a:ext cx="857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 section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ACF39AA4-177F-623F-411F-9DD84F948177}"/>
              </a:ext>
            </a:extLst>
          </p:cNvPr>
          <p:cNvSpPr txBox="1"/>
          <p:nvPr/>
        </p:nvSpPr>
        <p:spPr>
          <a:xfrm>
            <a:off x="3420577" y="1063639"/>
            <a:ext cx="9156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S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moval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F37826BD-543D-9A4E-1EF4-D7A3EA352A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2674057"/>
              </p:ext>
            </p:extLst>
          </p:nvPr>
        </p:nvGraphicFramePr>
        <p:xfrm>
          <a:off x="158420" y="4243364"/>
          <a:ext cx="3169986" cy="998939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636136">
                  <a:extLst>
                    <a:ext uri="{9D8B030D-6E8A-4147-A177-3AD203B41FA5}">
                      <a16:colId xmlns:a16="http://schemas.microsoft.com/office/drawing/2014/main" val="1277197416"/>
                    </a:ext>
                  </a:extLst>
                </a:gridCol>
                <a:gridCol w="1273471">
                  <a:extLst>
                    <a:ext uri="{9D8B030D-6E8A-4147-A177-3AD203B41FA5}">
                      <a16:colId xmlns:a16="http://schemas.microsoft.com/office/drawing/2014/main" val="3382227845"/>
                    </a:ext>
                  </a:extLst>
                </a:gridCol>
                <a:gridCol w="1260379">
                  <a:extLst>
                    <a:ext uri="{9D8B030D-6E8A-4147-A177-3AD203B41FA5}">
                      <a16:colId xmlns:a16="http://schemas.microsoft.com/office/drawing/2014/main" val="363667501"/>
                    </a:ext>
                  </a:extLst>
                </a:gridCol>
              </a:tblGrid>
              <a:tr h="169232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(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V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7665871"/>
                  </a:ext>
                </a:extLst>
              </a:tr>
              <a:tr h="186443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85 (0.81–0.89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44 (1.33–1.55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12345680"/>
                  </a:ext>
                </a:extLst>
              </a:tr>
              <a:tr h="169232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16 (1.11–1.21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8 (1.68–1.92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415413905"/>
                  </a:ext>
                </a:extLst>
              </a:tr>
              <a:tr h="169232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36 (1.3–1.42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99 (1.86–2.12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68265657"/>
                  </a:ext>
                </a:extLst>
              </a:tr>
              <a:tr h="169232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43 (1.37–1.49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1 (1.96–2.24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378539236"/>
                  </a:ext>
                </a:extLst>
              </a:tr>
            </a:tbl>
          </a:graphicData>
        </a:graphic>
      </p:graphicFrame>
      <p:graphicFrame>
        <p:nvGraphicFramePr>
          <p:cNvPr id="7" name="Tableau 6">
            <a:extLst>
              <a:ext uri="{FF2B5EF4-FFF2-40B4-BE49-F238E27FC236}">
                <a16:creationId xmlns:a16="http://schemas.microsoft.com/office/drawing/2014/main" id="{CB4EFE43-22AB-C450-4EF1-8547506CE4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2062046"/>
              </p:ext>
            </p:extLst>
          </p:nvPr>
        </p:nvGraphicFramePr>
        <p:xfrm>
          <a:off x="3567695" y="4263712"/>
          <a:ext cx="3150736" cy="982632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554981">
                  <a:extLst>
                    <a:ext uri="{9D8B030D-6E8A-4147-A177-3AD203B41FA5}">
                      <a16:colId xmlns:a16="http://schemas.microsoft.com/office/drawing/2014/main" val="1277197416"/>
                    </a:ext>
                  </a:extLst>
                </a:gridCol>
                <a:gridCol w="1335376">
                  <a:extLst>
                    <a:ext uri="{9D8B030D-6E8A-4147-A177-3AD203B41FA5}">
                      <a16:colId xmlns:a16="http://schemas.microsoft.com/office/drawing/2014/main" val="3382227845"/>
                    </a:ext>
                  </a:extLst>
                </a:gridCol>
                <a:gridCol w="1260379">
                  <a:extLst>
                    <a:ext uri="{9D8B030D-6E8A-4147-A177-3AD203B41FA5}">
                      <a16:colId xmlns:a16="http://schemas.microsoft.com/office/drawing/2014/main" val="363667501"/>
                    </a:ext>
                  </a:extLst>
                </a:gridCol>
              </a:tblGrid>
              <a:tr h="65208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(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V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7665871"/>
                  </a:ext>
                </a:extLst>
              </a:tr>
              <a:tr h="175144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77 (0.73–0.81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04 (0.94–1.13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12345680"/>
                  </a:ext>
                </a:extLst>
              </a:tr>
              <a:tr h="175144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37 (1.32–1.43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65 (1.53–1.77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415413905"/>
                  </a:ext>
                </a:extLst>
              </a:tr>
              <a:tr h="175144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88 (1.81–1.95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16 (2.02–2.3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68265657"/>
                  </a:ext>
                </a:extLst>
              </a:tr>
              <a:tr h="144602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14 (2.06–2.22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53 (2.36–2.7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378539236"/>
                  </a:ext>
                </a:extLst>
              </a:tr>
            </a:tbl>
          </a:graphicData>
        </a:graphic>
      </p:graphicFrame>
      <p:graphicFrame>
        <p:nvGraphicFramePr>
          <p:cNvPr id="8" name="Tableau 7">
            <a:extLst>
              <a:ext uri="{FF2B5EF4-FFF2-40B4-BE49-F238E27FC236}">
                <a16:creationId xmlns:a16="http://schemas.microsoft.com/office/drawing/2014/main" id="{05592078-199F-6F97-A2B7-EA1EFA9A1C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1369130"/>
              </p:ext>
            </p:extLst>
          </p:nvPr>
        </p:nvGraphicFramePr>
        <p:xfrm>
          <a:off x="3648719" y="8716224"/>
          <a:ext cx="3150736" cy="914400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556145">
                  <a:extLst>
                    <a:ext uri="{9D8B030D-6E8A-4147-A177-3AD203B41FA5}">
                      <a16:colId xmlns:a16="http://schemas.microsoft.com/office/drawing/2014/main" val="1277197416"/>
                    </a:ext>
                  </a:extLst>
                </a:gridCol>
                <a:gridCol w="1334212">
                  <a:extLst>
                    <a:ext uri="{9D8B030D-6E8A-4147-A177-3AD203B41FA5}">
                      <a16:colId xmlns:a16="http://schemas.microsoft.com/office/drawing/2014/main" val="3382227845"/>
                    </a:ext>
                  </a:extLst>
                </a:gridCol>
                <a:gridCol w="1260379">
                  <a:extLst>
                    <a:ext uri="{9D8B030D-6E8A-4147-A177-3AD203B41FA5}">
                      <a16:colId xmlns:a16="http://schemas.microsoft.com/office/drawing/2014/main" val="363667501"/>
                    </a:ext>
                  </a:extLst>
                </a:gridCol>
              </a:tblGrid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(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V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7665871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51 (1.45 - 1.57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57 (2.42–2.72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12345680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42 (2.35 - 2.5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3.66 (3.48–3.84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415413905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3.74 (3.64 - 3.84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5.16 (4.94–5.38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68265657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4.68 (4.55 - 4.81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6.21 (5.93–6.48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378539236"/>
                  </a:ext>
                </a:extLst>
              </a:tr>
            </a:tbl>
          </a:graphicData>
        </a:graphic>
      </p:graphicFrame>
      <p:graphicFrame>
        <p:nvGraphicFramePr>
          <p:cNvPr id="20" name="Tableau 19">
            <a:extLst>
              <a:ext uri="{FF2B5EF4-FFF2-40B4-BE49-F238E27FC236}">
                <a16:creationId xmlns:a16="http://schemas.microsoft.com/office/drawing/2014/main" id="{4EA58CFA-E7A9-8267-3706-48C318044C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4990133"/>
              </p:ext>
            </p:extLst>
          </p:nvPr>
        </p:nvGraphicFramePr>
        <p:xfrm>
          <a:off x="298935" y="8716224"/>
          <a:ext cx="3150736" cy="914400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649841">
                  <a:extLst>
                    <a:ext uri="{9D8B030D-6E8A-4147-A177-3AD203B41FA5}">
                      <a16:colId xmlns:a16="http://schemas.microsoft.com/office/drawing/2014/main" val="1277197416"/>
                    </a:ext>
                  </a:extLst>
                </a:gridCol>
                <a:gridCol w="1240516">
                  <a:extLst>
                    <a:ext uri="{9D8B030D-6E8A-4147-A177-3AD203B41FA5}">
                      <a16:colId xmlns:a16="http://schemas.microsoft.com/office/drawing/2014/main" val="3382227845"/>
                    </a:ext>
                  </a:extLst>
                </a:gridCol>
                <a:gridCol w="1260379">
                  <a:extLst>
                    <a:ext uri="{9D8B030D-6E8A-4147-A177-3AD203B41FA5}">
                      <a16:colId xmlns:a16="http://schemas.microsoft.com/office/drawing/2014/main" val="363667501"/>
                    </a:ext>
                  </a:extLst>
                </a:gridCol>
              </a:tblGrid>
              <a:tr h="127609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(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V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7665871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69 (0.65–0.73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59 (0.52–0.66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12345680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72 (1.66–1.78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42 (1.31–1.53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415413905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48 (2.4–2.56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13 (1.99–2.28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68265657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96 (2.86–3.06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46 (2.29–2.63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378539236"/>
                  </a:ext>
                </a:extLst>
              </a:tr>
            </a:tbl>
          </a:graphicData>
        </a:graphic>
      </p:graphicFrame>
      <p:pic>
        <p:nvPicPr>
          <p:cNvPr id="21" name="Image 20">
            <a:extLst>
              <a:ext uri="{FF2B5EF4-FFF2-40B4-BE49-F238E27FC236}">
                <a16:creationId xmlns:a16="http://schemas.microsoft.com/office/drawing/2014/main" id="{DDA1C692-8BDA-2D9E-543E-24683C5EEB3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47" r="50000"/>
          <a:stretch/>
        </p:blipFill>
        <p:spPr>
          <a:xfrm>
            <a:off x="230387" y="1267268"/>
            <a:ext cx="2880360" cy="2839720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90C3987F-0741-14CE-8414-047A2E32DC3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59" r="50000"/>
          <a:stretch/>
        </p:blipFill>
        <p:spPr>
          <a:xfrm>
            <a:off x="3567695" y="1267268"/>
            <a:ext cx="2559936" cy="2839720"/>
          </a:xfrm>
          <a:prstGeom prst="rect">
            <a:avLst/>
          </a:prstGeom>
        </p:spPr>
      </p:pic>
      <p:sp>
        <p:nvSpPr>
          <p:cNvPr id="23" name="ZoneTexte 22">
            <a:extLst>
              <a:ext uri="{FF2B5EF4-FFF2-40B4-BE49-F238E27FC236}">
                <a16:creationId xmlns:a16="http://schemas.microsoft.com/office/drawing/2014/main" id="{FD42C9DA-7088-58E7-55D8-D742FAF4603D}"/>
              </a:ext>
            </a:extLst>
          </p:cNvPr>
          <p:cNvSpPr txBox="1"/>
          <p:nvPr/>
        </p:nvSpPr>
        <p:spPr>
          <a:xfrm>
            <a:off x="298935" y="5344552"/>
            <a:ext cx="29339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MUS implantation</a:t>
            </a:r>
          </a:p>
        </p:txBody>
      </p:sp>
      <p:pic>
        <p:nvPicPr>
          <p:cNvPr id="24" name="Image 23">
            <a:extLst>
              <a:ext uri="{FF2B5EF4-FFF2-40B4-BE49-F238E27FC236}">
                <a16:creationId xmlns:a16="http://schemas.microsoft.com/office/drawing/2014/main" id="{88D40584-440B-81BF-A899-3E959B7432F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81" r="49070"/>
          <a:stretch/>
        </p:blipFill>
        <p:spPr>
          <a:xfrm>
            <a:off x="561375" y="5707082"/>
            <a:ext cx="2307117" cy="2839720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8E9962E2-B87F-3517-497B-2868135006F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93" r="51690"/>
          <a:stretch/>
        </p:blipFill>
        <p:spPr>
          <a:xfrm>
            <a:off x="3820514" y="5700508"/>
            <a:ext cx="2317711" cy="2762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6276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595A2981-801F-5275-4D81-A1B7F12EB2EA}"/>
              </a:ext>
            </a:extLst>
          </p:cNvPr>
          <p:cNvSpPr txBox="1"/>
          <p:nvPr/>
        </p:nvSpPr>
        <p:spPr>
          <a:xfrm>
            <a:off x="3707264" y="170201"/>
            <a:ext cx="2268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Hospitalizations for MUS erosion</a:t>
            </a:r>
          </a:p>
        </p:txBody>
      </p:sp>
      <p:graphicFrame>
        <p:nvGraphicFramePr>
          <p:cNvPr id="6" name="Tableau 5">
            <a:extLst>
              <a:ext uri="{FF2B5EF4-FFF2-40B4-BE49-F238E27FC236}">
                <a16:creationId xmlns:a16="http://schemas.microsoft.com/office/drawing/2014/main" id="{3140E7C2-AD24-50C8-62FE-95E54009BA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426780"/>
              </p:ext>
            </p:extLst>
          </p:nvPr>
        </p:nvGraphicFramePr>
        <p:xfrm>
          <a:off x="3657601" y="3692088"/>
          <a:ext cx="3150736" cy="929632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596899">
                  <a:extLst>
                    <a:ext uri="{9D8B030D-6E8A-4147-A177-3AD203B41FA5}">
                      <a16:colId xmlns:a16="http://schemas.microsoft.com/office/drawing/2014/main" val="1277197416"/>
                    </a:ext>
                  </a:extLst>
                </a:gridCol>
                <a:gridCol w="1293458">
                  <a:extLst>
                    <a:ext uri="{9D8B030D-6E8A-4147-A177-3AD203B41FA5}">
                      <a16:colId xmlns:a16="http://schemas.microsoft.com/office/drawing/2014/main" val="3382227845"/>
                    </a:ext>
                  </a:extLst>
                </a:gridCol>
                <a:gridCol w="1260379">
                  <a:extLst>
                    <a:ext uri="{9D8B030D-6E8A-4147-A177-3AD203B41FA5}">
                      <a16:colId xmlns:a16="http://schemas.microsoft.com/office/drawing/2014/main" val="363667501"/>
                    </a:ext>
                  </a:extLst>
                </a:gridCol>
              </a:tblGrid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(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V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7665871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72 (0.68–0.76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11 (1.01–1.21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12345680"/>
                  </a:ext>
                </a:extLst>
              </a:tr>
              <a:tr h="167632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3 (1.24–1.35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8 (1.68–1.93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415413905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1.92 (1.85–1.99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43 (2.28–2.58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68265657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25 (2.17–2.34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96 (2.77–3.15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378539236"/>
                  </a:ext>
                </a:extLst>
              </a:tr>
            </a:tbl>
          </a:graphicData>
        </a:graphic>
      </p:graphicFrame>
      <p:graphicFrame>
        <p:nvGraphicFramePr>
          <p:cNvPr id="8" name="Tableau 7">
            <a:extLst>
              <a:ext uri="{FF2B5EF4-FFF2-40B4-BE49-F238E27FC236}">
                <a16:creationId xmlns:a16="http://schemas.microsoft.com/office/drawing/2014/main" id="{FF6F3333-B8C1-C1E7-71A9-BDFA8237B4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7852797"/>
              </p:ext>
            </p:extLst>
          </p:nvPr>
        </p:nvGraphicFramePr>
        <p:xfrm>
          <a:off x="278264" y="3686391"/>
          <a:ext cx="3150736" cy="935329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585336">
                  <a:extLst>
                    <a:ext uri="{9D8B030D-6E8A-4147-A177-3AD203B41FA5}">
                      <a16:colId xmlns:a16="http://schemas.microsoft.com/office/drawing/2014/main" val="1277197416"/>
                    </a:ext>
                  </a:extLst>
                </a:gridCol>
                <a:gridCol w="1305021">
                  <a:extLst>
                    <a:ext uri="{9D8B030D-6E8A-4147-A177-3AD203B41FA5}">
                      <a16:colId xmlns:a16="http://schemas.microsoft.com/office/drawing/2014/main" val="3382227845"/>
                    </a:ext>
                  </a:extLst>
                </a:gridCol>
                <a:gridCol w="1260379">
                  <a:extLst>
                    <a:ext uri="{9D8B030D-6E8A-4147-A177-3AD203B41FA5}">
                      <a16:colId xmlns:a16="http://schemas.microsoft.com/office/drawing/2014/main" val="363667501"/>
                    </a:ext>
                  </a:extLst>
                </a:gridCol>
              </a:tblGrid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(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)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V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7665871"/>
                  </a:ext>
                </a:extLst>
              </a:tr>
              <a:tr h="173329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14 (0.12–0.16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21 (0.17–0.25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112345680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32 (0.29–0.35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42 (0.36–0.48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415413905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62 (0.58–0.66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66 (0.58–0.75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68265657"/>
                  </a:ext>
                </a:extLst>
              </a:tr>
              <a:tr h="10031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78 (0.73–0.84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0.93 (0.81–1.04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378539236"/>
                  </a:ext>
                </a:extLst>
              </a:tr>
            </a:tbl>
          </a:graphicData>
        </a:graphic>
      </p:graphicFrame>
      <p:sp>
        <p:nvSpPr>
          <p:cNvPr id="9" name="ZoneTexte 8">
            <a:extLst>
              <a:ext uri="{FF2B5EF4-FFF2-40B4-BE49-F238E27FC236}">
                <a16:creationId xmlns:a16="http://schemas.microsoft.com/office/drawing/2014/main" id="{AF8724C4-D9C7-4409-1833-5694977F9C89}"/>
              </a:ext>
            </a:extLst>
          </p:cNvPr>
          <p:cNvSpPr txBox="1"/>
          <p:nvPr/>
        </p:nvSpPr>
        <p:spPr>
          <a:xfrm>
            <a:off x="635103" y="170202"/>
            <a:ext cx="2492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Hospitalizations for MUS infection	</a:t>
            </a:r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9659A635-6CAC-918B-F647-B4F39A80D2A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37" r="50000"/>
          <a:stretch/>
        </p:blipFill>
        <p:spPr>
          <a:xfrm>
            <a:off x="375754" y="525053"/>
            <a:ext cx="2358639" cy="2977938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0F81056C-6F31-8712-7FE7-0371055CB41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959" t="7837" r="49649"/>
          <a:stretch/>
        </p:blipFill>
        <p:spPr>
          <a:xfrm>
            <a:off x="3293826" y="408476"/>
            <a:ext cx="2682008" cy="3095629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90710ADF-31B1-87D9-B4B3-41FEAA699018}"/>
              </a:ext>
            </a:extLst>
          </p:cNvPr>
          <p:cNvSpPr txBox="1"/>
          <p:nvPr/>
        </p:nvSpPr>
        <p:spPr>
          <a:xfrm>
            <a:off x="709480" y="5786343"/>
            <a:ext cx="1992853" cy="7694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CA" sz="1100" kern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T: Trans-Obturator Tape</a:t>
            </a:r>
          </a:p>
          <a:p>
            <a:r>
              <a:rPr lang="en-CA" sz="1100" kern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VT: Tension-free Vaginal Tape </a:t>
            </a:r>
          </a:p>
          <a:p>
            <a:r>
              <a:rPr lang="fr-FR" sz="1100" dirty="0">
                <a:cs typeface="Times New Roman" panose="02020603050405020304" pitchFamily="18" charset="0"/>
              </a:rPr>
              <a:t>MUS: </a:t>
            </a:r>
            <a:r>
              <a:rPr lang="fr-FR" sz="1100" dirty="0" err="1">
                <a:cs typeface="Times New Roman" panose="02020603050405020304" pitchFamily="18" charset="0"/>
              </a:rPr>
              <a:t>Mid-urethral</a:t>
            </a:r>
            <a:r>
              <a:rPr lang="fr-FR" sz="1100" dirty="0">
                <a:cs typeface="Times New Roman" panose="02020603050405020304" pitchFamily="18" charset="0"/>
              </a:rPr>
              <a:t> sling</a:t>
            </a:r>
          </a:p>
          <a:p>
            <a:r>
              <a:rPr lang="fr-FR" sz="1100" dirty="0">
                <a:cs typeface="Times New Roman" panose="02020603050405020304" pitchFamily="18" charset="0"/>
              </a:rPr>
              <a:t>CI: Confidence </a:t>
            </a:r>
            <a:r>
              <a:rPr lang="fr-FR" sz="1100" dirty="0" err="1">
                <a:cs typeface="Times New Roman" panose="02020603050405020304" pitchFamily="18" charset="0"/>
              </a:rPr>
              <a:t>Interval</a:t>
            </a:r>
            <a:endParaRPr lang="fr-FR" sz="11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4544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E0457D20-2F44-1473-ED27-8DF9214195A1}"/>
              </a:ext>
            </a:extLst>
          </p:cNvPr>
          <p:cNvSpPr txBox="1"/>
          <p:nvPr/>
        </p:nvSpPr>
        <p:spPr>
          <a:xfrm>
            <a:off x="298902" y="301758"/>
            <a:ext cx="62601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: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de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mulative incidence of at least one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vere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lication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d-urethral</a:t>
            </a:r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ling (MUS) implantation</a:t>
            </a:r>
          </a:p>
          <a:p>
            <a:endParaRPr lang="fr-FR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rk</a:t>
            </a:r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s</a:t>
            </a:r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cumulative incidence, and th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ghter</a:t>
            </a:r>
            <a:r>
              <a:rPr lang="fr-FR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a the 95% confidence </a:t>
            </a:r>
            <a:r>
              <a:rPr lang="fr-FR" sz="1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val</a:t>
            </a:r>
            <a:endParaRPr lang="fr-FR" sz="1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leau 7">
            <a:extLst>
              <a:ext uri="{FF2B5EF4-FFF2-40B4-BE49-F238E27FC236}">
                <a16:creationId xmlns:a16="http://schemas.microsoft.com/office/drawing/2014/main" id="{37D5AEFE-94E8-7B68-778B-1935CFE37F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7149551"/>
              </p:ext>
            </p:extLst>
          </p:nvPr>
        </p:nvGraphicFramePr>
        <p:xfrm>
          <a:off x="532096" y="4428437"/>
          <a:ext cx="4643436" cy="762000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928440">
                  <a:extLst>
                    <a:ext uri="{9D8B030D-6E8A-4147-A177-3AD203B41FA5}">
                      <a16:colId xmlns:a16="http://schemas.microsoft.com/office/drawing/2014/main" val="1277197416"/>
                    </a:ext>
                  </a:extLst>
                </a:gridCol>
                <a:gridCol w="1857498">
                  <a:extLst>
                    <a:ext uri="{9D8B030D-6E8A-4147-A177-3AD203B41FA5}">
                      <a16:colId xmlns:a16="http://schemas.microsoft.com/office/drawing/2014/main" val="3382227845"/>
                    </a:ext>
                  </a:extLst>
                </a:gridCol>
                <a:gridCol w="1857498">
                  <a:extLst>
                    <a:ext uri="{9D8B030D-6E8A-4147-A177-3AD203B41FA5}">
                      <a16:colId xmlns:a16="http://schemas.microsoft.com/office/drawing/2014/main" val="363667501"/>
                    </a:ext>
                  </a:extLst>
                </a:gridCol>
              </a:tblGrid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(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O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VT </a:t>
                      </a:r>
                      <a:r>
                        <a:rPr lang="fr-FR" sz="1000" kern="1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ude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cidence 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%CI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extLst>
                  <a:ext uri="{0D108BD9-81ED-4DB2-BD59-A6C34878D82A}">
                    <a16:rowId xmlns:a16="http://schemas.microsoft.com/office/drawing/2014/main" val="1677665871"/>
                  </a:ext>
                </a:extLst>
              </a:tr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63500" marR="63500" algn="ct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2.32 (2.24–2.39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3.63 (3.46–3.8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978678880"/>
                  </a:ext>
                </a:extLst>
              </a:tr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fr-FR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63500" marR="63500" algn="ct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3.89 (3.8–3.99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5.43 (5.22–5.64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415413905"/>
                  </a:ext>
                </a:extLst>
              </a:tr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63500" marR="63500" algn="ct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5.85 (5.73–5.98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7.55 (7.28–7.81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4068265657"/>
                  </a:ext>
                </a:extLst>
              </a:tr>
              <a:tr h="148590">
                <a:tc>
                  <a:txBody>
                    <a:bodyPr/>
                    <a:lstStyle/>
                    <a:p>
                      <a:pPr algn="ctr"/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000" kern="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5721" marR="55721" marT="0" marB="0"/>
                </a:tc>
                <a:tc>
                  <a:txBody>
                    <a:bodyPr/>
                    <a:lstStyle/>
                    <a:p>
                      <a:pPr marL="63500" marR="63500" algn="ct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7.12 (6.96–7.27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63500" marR="63500" algn="ctr">
                        <a:spcBef>
                          <a:spcPts val="500"/>
                        </a:spcBef>
                        <a:spcAft>
                          <a:spcPts val="50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DejaVu Sans"/>
                          <a:cs typeface="Times New Roman" panose="02020603050405020304" pitchFamily="18" charset="0"/>
                        </a:rPr>
                        <a:t>9.07 (8.75– 9.39)</a:t>
                      </a:r>
                      <a:endParaRPr lang="fr-FR" sz="1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378539236"/>
                  </a:ext>
                </a:extLst>
              </a:tr>
            </a:tbl>
          </a:graphicData>
        </a:graphic>
      </p:graphicFrame>
      <p:pic>
        <p:nvPicPr>
          <p:cNvPr id="4" name="Image 3">
            <a:extLst>
              <a:ext uri="{FF2B5EF4-FFF2-40B4-BE49-F238E27FC236}">
                <a16:creationId xmlns:a16="http://schemas.microsoft.com/office/drawing/2014/main" id="{79ACF1F8-C04B-DF24-A011-DDEE7D126A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52" r="50000"/>
          <a:stretch/>
        </p:blipFill>
        <p:spPr>
          <a:xfrm>
            <a:off x="1243297" y="1222391"/>
            <a:ext cx="2340293" cy="2919044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D295C8F5-07E5-522D-BFFF-08E262C11FE5}"/>
              </a:ext>
            </a:extLst>
          </p:cNvPr>
          <p:cNvSpPr txBox="1"/>
          <p:nvPr/>
        </p:nvSpPr>
        <p:spPr>
          <a:xfrm>
            <a:off x="532096" y="5605791"/>
            <a:ext cx="1960793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CA" sz="1100" kern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T: Trans-Obturator Tape</a:t>
            </a:r>
          </a:p>
          <a:p>
            <a:r>
              <a:rPr lang="en-CA" sz="1100" kern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VT: Tension-free Vaginal Tape</a:t>
            </a:r>
          </a:p>
          <a:p>
            <a:r>
              <a:rPr lang="fr-FR" sz="1100" dirty="0">
                <a:cs typeface="Times New Roman" panose="02020603050405020304" pitchFamily="18" charset="0"/>
              </a:rPr>
              <a:t>CI: Confidence </a:t>
            </a:r>
            <a:r>
              <a:rPr lang="fr-FR" sz="1100" dirty="0" err="1">
                <a:cs typeface="Times New Roman" panose="02020603050405020304" pitchFamily="18" charset="0"/>
              </a:rPr>
              <a:t>Interval</a:t>
            </a:r>
            <a:r>
              <a:rPr lang="en-CA" sz="1100" kern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7402190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525</TotalTime>
  <Words>1419</Words>
  <Application>Microsoft Macintosh PowerPoint</Application>
  <PresentationFormat>Format A4 (210 x 297 mm)</PresentationFormat>
  <Paragraphs>371</Paragraphs>
  <Slides>10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Thème Office</vt:lpstr>
      <vt:lpstr>Supplemental</vt:lpstr>
      <vt:lpstr>Supplemental 1: Codes of identification of complications</vt:lpstr>
      <vt:lpstr>Présentation PowerPoint</vt:lpstr>
      <vt:lpstr>Présentation PowerPoint</vt:lpstr>
      <vt:lpstr>Supplemental 3: Distribution of first mid-urethral slings (MUS) implantation by year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yrille Guillot-Tantay</dc:creator>
  <cp:lastModifiedBy>Cyrille Guillot-Tantay</cp:lastModifiedBy>
  <cp:revision>83</cp:revision>
  <dcterms:created xsi:type="dcterms:W3CDTF">2024-10-25T11:44:14Z</dcterms:created>
  <dcterms:modified xsi:type="dcterms:W3CDTF">2025-06-18T15:37:29Z</dcterms:modified>
</cp:coreProperties>
</file>